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5"/>
  </p:sldMasterIdLst>
  <p:notesMasterIdLst>
    <p:notesMasterId r:id="rId7"/>
  </p:notesMasterIdLst>
  <p:sldIdLst>
    <p:sldId id="26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579"/>
    <a:srgbClr val="FF2600"/>
    <a:srgbClr val="FFAF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44"/>
    <p:restoredTop sz="94643"/>
  </p:normalViewPr>
  <p:slideViewPr>
    <p:cSldViewPr snapToGrid="0">
      <p:cViewPr varScale="1">
        <p:scale>
          <a:sx n="120" d="100"/>
          <a:sy n="120" d="100"/>
        </p:scale>
        <p:origin x="568" y="176"/>
      </p:cViewPr>
      <p:guideLst>
        <p:guide orient="horz" pos="10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10" Type="http://schemas.openxmlformats.org/officeDocument/2006/relationships/theme" Target="theme/theme1.xml"/><Relationship Id="rId4" Type="http://schemas.openxmlformats.org/officeDocument/2006/relationships/customXml" Target="../customXml/item4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989298-0953-2443-B02A-D47EA2CC1A72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EF5E5-D6DD-B04A-8D5F-BE3183C64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7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EF5E5-D6DD-B04A-8D5F-BE3183C64BA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984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742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0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4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20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23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2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50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79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218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87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44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29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182701" y="36933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420094" y="3693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40885" y="3443941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15" t="7301" r="658" b="5156"/>
          <a:stretch/>
        </p:blipFill>
        <p:spPr>
          <a:xfrm>
            <a:off x="1379141" y="964740"/>
            <a:ext cx="4572000" cy="238671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15" t="7301" r="606"/>
          <a:stretch/>
        </p:blipFill>
        <p:spPr>
          <a:xfrm>
            <a:off x="6726588" y="936375"/>
            <a:ext cx="4572000" cy="252576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420094" y="344394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48" t="7301" r="684"/>
          <a:stretch/>
        </p:blipFill>
        <p:spPr>
          <a:xfrm>
            <a:off x="1379141" y="4032474"/>
            <a:ext cx="4572000" cy="2531945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62" t="7751" r="605"/>
          <a:stretch/>
        </p:blipFill>
        <p:spPr>
          <a:xfrm>
            <a:off x="6726588" y="4063579"/>
            <a:ext cx="4572000" cy="2494663"/>
          </a:xfrm>
          <a:prstGeom prst="rect">
            <a:avLst/>
          </a:prstGeom>
        </p:spPr>
      </p:pic>
      <p:grpSp>
        <p:nvGrpSpPr>
          <p:cNvPr id="20" name="Group 19"/>
          <p:cNvGrpSpPr/>
          <p:nvPr/>
        </p:nvGrpSpPr>
        <p:grpSpPr>
          <a:xfrm>
            <a:off x="2145146" y="403798"/>
            <a:ext cx="2879143" cy="682656"/>
            <a:chOff x="6214638" y="708598"/>
            <a:chExt cx="2879143" cy="682656"/>
          </a:xfrm>
        </p:grpSpPr>
        <p:grpSp>
          <p:nvGrpSpPr>
            <p:cNvPr id="21" name="Group 20"/>
            <p:cNvGrpSpPr/>
            <p:nvPr/>
          </p:nvGrpSpPr>
          <p:grpSpPr>
            <a:xfrm>
              <a:off x="6214638" y="889274"/>
              <a:ext cx="2626341" cy="154065"/>
              <a:chOff x="8525482" y="2047962"/>
              <a:chExt cx="2626341" cy="154065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8525482" y="2200316"/>
                <a:ext cx="2611351" cy="0"/>
              </a:xfrm>
              <a:prstGeom prst="line">
                <a:avLst/>
              </a:prstGeom>
              <a:ln w="25400" cmpd="dbl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riangle 27"/>
              <p:cNvSpPr/>
              <p:nvPr/>
            </p:nvSpPr>
            <p:spPr>
              <a:xfrm rot="10800000">
                <a:off x="9934438" y="2047962"/>
                <a:ext cx="215126" cy="146542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riangle 28"/>
              <p:cNvSpPr/>
              <p:nvPr/>
            </p:nvSpPr>
            <p:spPr>
              <a:xfrm rot="10800000">
                <a:off x="9085047" y="2049106"/>
                <a:ext cx="215126" cy="146542"/>
              </a:xfrm>
              <a:prstGeom prst="triangl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8525482" y="2202027"/>
                <a:ext cx="663934" cy="0"/>
              </a:xfrm>
              <a:prstGeom prst="line">
                <a:avLst/>
              </a:prstGeom>
              <a:ln w="50800">
                <a:solidFill>
                  <a:srgbClr val="FFC00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10056467" y="2200316"/>
                <a:ext cx="1095356" cy="0"/>
              </a:xfrm>
              <a:prstGeom prst="line">
                <a:avLst/>
              </a:prstGeom>
              <a:ln w="50800">
                <a:solidFill>
                  <a:srgbClr val="FF000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9189416" y="2201444"/>
                <a:ext cx="864833" cy="0"/>
              </a:xfrm>
              <a:prstGeom prst="line">
                <a:avLst/>
              </a:prstGeom>
              <a:ln w="50800">
                <a:solidFill>
                  <a:srgbClr val="0070C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V="1">
                <a:off x="9578295" y="2199885"/>
                <a:ext cx="280998" cy="1559"/>
              </a:xfrm>
              <a:prstGeom prst="line">
                <a:avLst/>
              </a:prstGeom>
              <a:ln w="50800">
                <a:solidFill>
                  <a:srgbClr val="0070C0">
                    <a:alpha val="50000"/>
                  </a:srgbClr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Box 21"/>
            <p:cNvSpPr txBox="1"/>
            <p:nvPr/>
          </p:nvSpPr>
          <p:spPr>
            <a:xfrm>
              <a:off x="6509619" y="713023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64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413879" y="708598"/>
              <a:ext cx="69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323</a:t>
              </a:r>
            </a:p>
          </p:txBody>
        </p:sp>
        <p:sp>
          <p:nvSpPr>
            <p:cNvPr id="24" name="Rectangle 23"/>
            <p:cNvSpPr/>
            <p:nvPr/>
          </p:nvSpPr>
          <p:spPr>
            <a:xfrm rot="10800000">
              <a:off x="8533792" y="935036"/>
              <a:ext cx="354752" cy="207251"/>
            </a:xfrm>
            <a:prstGeom prst="rect">
              <a:avLst/>
            </a:prstGeom>
            <a:gradFill>
              <a:gsLst>
                <a:gs pos="100000">
                  <a:schemeClr val="bg1">
                    <a:alpha val="0"/>
                  </a:schemeClr>
                </a:gs>
                <a:gs pos="58000">
                  <a:schemeClr val="bg1"/>
                </a:gs>
              </a:gsLst>
              <a:lin ang="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 flipH="1">
              <a:off x="7883507" y="1146716"/>
              <a:ext cx="218856" cy="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26" name="TextBox 25"/>
            <p:cNvSpPr txBox="1"/>
            <p:nvPr/>
          </p:nvSpPr>
          <p:spPr>
            <a:xfrm>
              <a:off x="7974564" y="1129644"/>
              <a:ext cx="1119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UDiTaS primer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8344041" y="320970"/>
            <a:ext cx="2026289" cy="700240"/>
            <a:chOff x="6754133" y="1861446"/>
            <a:chExt cx="2026289" cy="700240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7434070" y="2206198"/>
              <a:ext cx="914400" cy="0"/>
            </a:xfrm>
            <a:prstGeom prst="line">
              <a:avLst/>
            </a:prstGeom>
            <a:ln w="25400" cmpd="dbl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6754133" y="2212060"/>
              <a:ext cx="667512" cy="0"/>
            </a:xfrm>
            <a:prstGeom prst="line">
              <a:avLst/>
            </a:prstGeom>
            <a:ln w="25400" cmpd="dbl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riangle 36"/>
            <p:cNvSpPr/>
            <p:nvPr/>
          </p:nvSpPr>
          <p:spPr>
            <a:xfrm rot="10800000">
              <a:off x="7313699" y="2060850"/>
              <a:ext cx="215126" cy="146542"/>
            </a:xfrm>
            <a:prstGeom prst="triangle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7432264" y="2212060"/>
              <a:ext cx="1095356" cy="0"/>
            </a:xfrm>
            <a:prstGeom prst="line">
              <a:avLst/>
            </a:prstGeom>
            <a:ln w="50800">
              <a:solidFill>
                <a:srgbClr val="FF0000">
                  <a:alpha val="50000"/>
                </a:srgb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6754134" y="2213771"/>
              <a:ext cx="663934" cy="0"/>
            </a:xfrm>
            <a:prstGeom prst="line">
              <a:avLst/>
            </a:prstGeom>
            <a:ln w="50800">
              <a:solidFill>
                <a:srgbClr val="FFC000">
                  <a:alpha val="50000"/>
                </a:srgb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6754573" y="1878445"/>
              <a:ext cx="633507" cy="2034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64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430233" y="1861446"/>
              <a:ext cx="69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323</a:t>
              </a:r>
            </a:p>
          </p:txBody>
        </p:sp>
        <p:sp>
          <p:nvSpPr>
            <p:cNvPr id="42" name="Rectangle 41"/>
            <p:cNvSpPr/>
            <p:nvPr/>
          </p:nvSpPr>
          <p:spPr>
            <a:xfrm rot="10800000">
              <a:off x="8176472" y="2105468"/>
              <a:ext cx="354752" cy="207251"/>
            </a:xfrm>
            <a:prstGeom prst="rect">
              <a:avLst/>
            </a:prstGeom>
            <a:gradFill>
              <a:gsLst>
                <a:gs pos="100000">
                  <a:schemeClr val="bg1">
                    <a:alpha val="0"/>
                  </a:schemeClr>
                </a:gs>
                <a:gs pos="58000">
                  <a:schemeClr val="bg1"/>
                </a:gs>
              </a:gsLst>
              <a:lin ang="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 flipH="1">
              <a:off x="7570148" y="2317148"/>
              <a:ext cx="218856" cy="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4" name="TextBox 43"/>
            <p:cNvSpPr txBox="1"/>
            <p:nvPr/>
          </p:nvSpPr>
          <p:spPr>
            <a:xfrm>
              <a:off x="7661205" y="2300076"/>
              <a:ext cx="1119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UDiTaS primer</a:t>
              </a: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7420708" y="2044213"/>
              <a:ext cx="123092" cy="1362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ight Triangle 45"/>
            <p:cNvSpPr/>
            <p:nvPr/>
          </p:nvSpPr>
          <p:spPr>
            <a:xfrm rot="10800000" flipH="1">
              <a:off x="7425104" y="2061796"/>
              <a:ext cx="109728" cy="146304"/>
            </a:xfrm>
            <a:prstGeom prst="rt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2116314" y="3485722"/>
            <a:ext cx="2879143" cy="682656"/>
            <a:chOff x="6367038" y="3172686"/>
            <a:chExt cx="2879143" cy="682656"/>
          </a:xfrm>
        </p:grpSpPr>
        <p:grpSp>
          <p:nvGrpSpPr>
            <p:cNvPr id="48" name="Group 47"/>
            <p:cNvGrpSpPr/>
            <p:nvPr/>
          </p:nvGrpSpPr>
          <p:grpSpPr>
            <a:xfrm>
              <a:off x="6367038" y="3353362"/>
              <a:ext cx="2626341" cy="154065"/>
              <a:chOff x="8525482" y="2047962"/>
              <a:chExt cx="2626341" cy="154065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>
                <a:off x="8525482" y="2200316"/>
                <a:ext cx="2611351" cy="0"/>
              </a:xfrm>
              <a:prstGeom prst="line">
                <a:avLst/>
              </a:prstGeom>
              <a:ln w="25400" cmpd="dbl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riangle 56"/>
              <p:cNvSpPr/>
              <p:nvPr/>
            </p:nvSpPr>
            <p:spPr>
              <a:xfrm rot="10800000">
                <a:off x="9934438" y="2047962"/>
                <a:ext cx="215126" cy="146542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Triangle 57"/>
              <p:cNvSpPr/>
              <p:nvPr/>
            </p:nvSpPr>
            <p:spPr>
              <a:xfrm rot="10800000">
                <a:off x="9085047" y="2049106"/>
                <a:ext cx="215126" cy="146542"/>
              </a:xfrm>
              <a:prstGeom prst="triangle">
                <a:avLst/>
              </a:prstGeom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>
                <a:off x="8525482" y="2202027"/>
                <a:ext cx="663934" cy="0"/>
              </a:xfrm>
              <a:prstGeom prst="line">
                <a:avLst/>
              </a:prstGeom>
              <a:ln w="50800">
                <a:solidFill>
                  <a:srgbClr val="FFC00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10056467" y="2200316"/>
                <a:ext cx="1095356" cy="0"/>
              </a:xfrm>
              <a:prstGeom prst="line">
                <a:avLst/>
              </a:prstGeom>
              <a:ln w="50800">
                <a:solidFill>
                  <a:srgbClr val="FF000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9189416" y="2201444"/>
                <a:ext cx="864833" cy="0"/>
              </a:xfrm>
              <a:prstGeom prst="line">
                <a:avLst/>
              </a:prstGeom>
              <a:ln w="50800">
                <a:solidFill>
                  <a:srgbClr val="0070C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/>
              <p:cNvCxnSpPr/>
              <p:nvPr/>
            </p:nvCxnSpPr>
            <p:spPr>
              <a:xfrm flipH="1" flipV="1">
                <a:off x="9578295" y="2199885"/>
                <a:ext cx="280998" cy="1559"/>
              </a:xfrm>
              <a:prstGeom prst="line">
                <a:avLst/>
              </a:prstGeom>
              <a:ln w="50800">
                <a:solidFill>
                  <a:srgbClr val="0070C0">
                    <a:alpha val="50000"/>
                  </a:srgbClr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TextBox 48"/>
            <p:cNvSpPr txBox="1"/>
            <p:nvPr/>
          </p:nvSpPr>
          <p:spPr>
            <a:xfrm>
              <a:off x="6662019" y="3177111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64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566279" y="3172686"/>
              <a:ext cx="69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guide 323</a:t>
              </a:r>
            </a:p>
          </p:txBody>
        </p:sp>
        <p:sp>
          <p:nvSpPr>
            <p:cNvPr id="51" name="Rectangle 50"/>
            <p:cNvSpPr/>
            <p:nvPr/>
          </p:nvSpPr>
          <p:spPr>
            <a:xfrm rot="10800000">
              <a:off x="8686192" y="3399124"/>
              <a:ext cx="354752" cy="207251"/>
            </a:xfrm>
            <a:prstGeom prst="rect">
              <a:avLst/>
            </a:prstGeom>
            <a:gradFill>
              <a:gsLst>
                <a:gs pos="100000">
                  <a:schemeClr val="bg1">
                    <a:alpha val="0"/>
                  </a:schemeClr>
                </a:gs>
                <a:gs pos="58000">
                  <a:schemeClr val="bg1"/>
                </a:gs>
              </a:gsLst>
              <a:lin ang="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 flipH="1">
              <a:off x="8035907" y="3610804"/>
              <a:ext cx="218856" cy="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53" name="TextBox 52"/>
            <p:cNvSpPr txBox="1"/>
            <p:nvPr/>
          </p:nvSpPr>
          <p:spPr>
            <a:xfrm>
              <a:off x="8126964" y="3593732"/>
              <a:ext cx="1119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UDiTaS primer</a:t>
              </a:r>
            </a:p>
          </p:txBody>
        </p:sp>
        <p:sp>
          <p:nvSpPr>
            <p:cNvPr id="54" name="Right Triangle 53"/>
            <p:cNvSpPr/>
            <p:nvPr/>
          </p:nvSpPr>
          <p:spPr>
            <a:xfrm rot="10800000" flipH="1">
              <a:off x="7039948" y="3355811"/>
              <a:ext cx="109728" cy="146304"/>
            </a:xfrm>
            <a:prstGeom prst="rt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ight Triangle 54"/>
            <p:cNvSpPr/>
            <p:nvPr/>
          </p:nvSpPr>
          <p:spPr>
            <a:xfrm rot="10800000">
              <a:off x="7782551" y="3355811"/>
              <a:ext cx="109728" cy="146304"/>
            </a:xfrm>
            <a:prstGeom prst="rtTriangle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7815432" y="3463647"/>
            <a:ext cx="2448209" cy="700240"/>
            <a:chOff x="6357152" y="4058777"/>
            <a:chExt cx="2448209" cy="700240"/>
          </a:xfrm>
        </p:grpSpPr>
        <p:cxnSp>
          <p:nvCxnSpPr>
            <p:cNvPr id="64" name="Straight Connector 63"/>
            <p:cNvCxnSpPr/>
            <p:nvPr/>
          </p:nvCxnSpPr>
          <p:spPr>
            <a:xfrm>
              <a:off x="7459009" y="4403529"/>
              <a:ext cx="914400" cy="0"/>
            </a:xfrm>
            <a:prstGeom prst="line">
              <a:avLst/>
            </a:prstGeom>
            <a:ln w="25400" cmpd="dbl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7457203" y="4409391"/>
              <a:ext cx="1095356" cy="0"/>
            </a:xfrm>
            <a:prstGeom prst="line">
              <a:avLst/>
            </a:prstGeom>
            <a:ln w="50800">
              <a:solidFill>
                <a:srgbClr val="FF0000">
                  <a:alpha val="50000"/>
                </a:srgb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7455172" y="4058777"/>
              <a:ext cx="699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/>
                <a:t>guide 323</a:t>
              </a:r>
            </a:p>
          </p:txBody>
        </p:sp>
        <p:sp>
          <p:nvSpPr>
            <p:cNvPr id="67" name="Rectangle 66"/>
            <p:cNvSpPr/>
            <p:nvPr/>
          </p:nvSpPr>
          <p:spPr>
            <a:xfrm rot="10800000">
              <a:off x="8201411" y="4302799"/>
              <a:ext cx="354752" cy="207251"/>
            </a:xfrm>
            <a:prstGeom prst="rect">
              <a:avLst/>
            </a:prstGeom>
            <a:gradFill>
              <a:gsLst>
                <a:gs pos="100000">
                  <a:schemeClr val="bg1">
                    <a:alpha val="0"/>
                  </a:schemeClr>
                </a:gs>
                <a:gs pos="58000">
                  <a:schemeClr val="bg1"/>
                </a:gs>
              </a:gsLst>
              <a:lin ang="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8" name="Straight Arrow Connector 67"/>
            <p:cNvCxnSpPr/>
            <p:nvPr/>
          </p:nvCxnSpPr>
          <p:spPr>
            <a:xfrm flipH="1">
              <a:off x="7595087" y="4514479"/>
              <a:ext cx="218856" cy="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69" name="TextBox 68"/>
            <p:cNvSpPr txBox="1"/>
            <p:nvPr/>
          </p:nvSpPr>
          <p:spPr>
            <a:xfrm>
              <a:off x="7686144" y="4497407"/>
              <a:ext cx="1119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UDiTaS primer</a:t>
              </a:r>
            </a:p>
          </p:txBody>
        </p:sp>
        <p:grpSp>
          <p:nvGrpSpPr>
            <p:cNvPr id="70" name="Group 69"/>
            <p:cNvGrpSpPr/>
            <p:nvPr/>
          </p:nvGrpSpPr>
          <p:grpSpPr>
            <a:xfrm flipH="1">
              <a:off x="6357152" y="4305571"/>
              <a:ext cx="1098960" cy="211680"/>
              <a:chOff x="7609603" y="5014924"/>
              <a:chExt cx="1098960" cy="211680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>
                <a:off x="7611409" y="5115654"/>
                <a:ext cx="914400" cy="0"/>
              </a:xfrm>
              <a:prstGeom prst="line">
                <a:avLst/>
              </a:prstGeom>
              <a:ln w="25400" cmpd="dbl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7609603" y="5121516"/>
                <a:ext cx="1095356" cy="0"/>
              </a:xfrm>
              <a:prstGeom prst="line">
                <a:avLst/>
              </a:prstGeom>
              <a:ln w="50800">
                <a:solidFill>
                  <a:srgbClr val="FF0000">
                    <a:alpha val="50000"/>
                  </a:srgb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Rectangle 73"/>
              <p:cNvSpPr/>
              <p:nvPr/>
            </p:nvSpPr>
            <p:spPr>
              <a:xfrm rot="10800000">
                <a:off x="8353811" y="5014924"/>
                <a:ext cx="354752" cy="207251"/>
              </a:xfrm>
              <a:prstGeom prst="rect">
                <a:avLst/>
              </a:prstGeom>
              <a:gradFill>
                <a:gsLst>
                  <a:gs pos="100000">
                    <a:schemeClr val="bg1">
                      <a:alpha val="0"/>
                    </a:schemeClr>
                  </a:gs>
                  <a:gs pos="58000">
                    <a:schemeClr val="bg1"/>
                  </a:gs>
                </a:gsLst>
                <a:lin ang="0" scaled="1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5" name="Straight Arrow Connector 74"/>
              <p:cNvCxnSpPr/>
              <p:nvPr/>
            </p:nvCxnSpPr>
            <p:spPr>
              <a:xfrm flipH="1">
                <a:off x="7747487" y="5226604"/>
                <a:ext cx="218856" cy="0"/>
              </a:xfrm>
              <a:prstGeom prst="straightConnector1">
                <a:avLst/>
              </a:prstGeom>
              <a:noFill/>
              <a:ln w="38100" cap="flat" cmpd="sng" algn="ctr">
                <a:solidFill>
                  <a:srgbClr val="C00000"/>
                </a:solidFill>
                <a:prstDash val="solid"/>
                <a:miter lim="800000"/>
                <a:tailEnd type="triangle"/>
              </a:ln>
              <a:effectLst/>
            </p:spPr>
          </p:cxnSp>
        </p:grpSp>
        <p:sp>
          <p:nvSpPr>
            <p:cNvPr id="71" name="Triangle 70"/>
            <p:cNvSpPr/>
            <p:nvPr/>
          </p:nvSpPr>
          <p:spPr>
            <a:xfrm rot="10800000">
              <a:off x="7365899" y="4261470"/>
              <a:ext cx="215126" cy="146542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06826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AEF66F112D50C4592BB43B6C12BA42A" ma:contentTypeVersion="6" ma:contentTypeDescription="Create a new document." ma:contentTypeScope="" ma:versionID="0aa399ac6f55e1232165d2bf87e81ab0">
  <xsd:schema xmlns:xsd="http://www.w3.org/2001/XMLSchema" xmlns:xs="http://www.w3.org/2001/XMLSchema" xmlns:p="http://schemas.microsoft.com/office/2006/metadata/properties" xmlns:ns2="923bde35-a2ff-4c15-8f8b-a555564e4c68" xmlns:ns3="efe164a0-f0b7-4eea-8df1-2ea8f3834e76" targetNamespace="http://schemas.microsoft.com/office/2006/metadata/properties" ma:root="true" ma:fieldsID="de9252aa466b859254c61ea80099f372" ns2:_="" ns3:_="">
    <xsd:import namespace="923bde35-a2ff-4c15-8f8b-a555564e4c68"/>
    <xsd:import namespace="efe164a0-f0b7-4eea-8df1-2ea8f3834e76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2:SharedWithUsers" minOccurs="0"/>
                <xsd:element ref="ns2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3bde35-a2ff-4c15-8f8b-a555564e4c68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Persist ID" ma:description="Keep ID on add." ma:hidden="true" ma:internalName="_dlc_DocIdPersistId" ma:readOnly="true">
      <xsd:simpleType>
        <xsd:restriction base="dms:Boolean"/>
      </xsd:simpleType>
    </xsd:element>
    <xsd:element name="SharedWithUsers" ma:index="15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e164a0-f0b7-4eea-8df1-2ea8f3834e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dlc_DocId xmlns="923bde35-a2ff-4c15-8f8b-a555564e4c68">EDOC-1461534248-1229</_dlc_DocId>
    <_dlc_DocIdUrl xmlns="923bde35-a2ff-4c15-8f8b-a555564e4c68">
      <Url>https://editasmed.sharepoint.com/Platform/_layouts/15/DocIdRedir.aspx?ID=EDOC-1461534248-1229</Url>
      <Description>EDOC-1461534248-1229</Description>
    </_dlc_DocIdUrl>
  </documentManagement>
</p:properties>
</file>

<file path=customXml/itemProps1.xml><?xml version="1.0" encoding="utf-8"?>
<ds:datastoreItem xmlns:ds="http://schemas.openxmlformats.org/officeDocument/2006/customXml" ds:itemID="{4EA13332-46F1-462B-9ED2-7814C6AE504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4C1E23D-87BF-4488-8768-687A5A776BA9}">
  <ds:schemaRefs>
    <ds:schemaRef ds:uri="923bde35-a2ff-4c15-8f8b-a555564e4c68"/>
    <ds:schemaRef ds:uri="efe164a0-f0b7-4eea-8df1-2ea8f3834e76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EBF38A0C-556C-4EA5-AB5A-865BF958D987}">
  <ds:schemaRefs>
    <ds:schemaRef ds:uri="http://schemas.microsoft.com/sharepoint/events"/>
  </ds:schemaRefs>
</ds:datastoreItem>
</file>

<file path=customXml/itemProps4.xml><?xml version="1.0" encoding="utf-8"?>
<ds:datastoreItem xmlns:ds="http://schemas.openxmlformats.org/officeDocument/2006/customXml" ds:itemID="{1C9F9E45-B1DF-4014-9D2A-1A916318FA4D}">
  <ds:schemaRefs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schemas.microsoft.com/office/2006/metadata/properties"/>
    <ds:schemaRef ds:uri="http://purl.org/dc/elements/1.1/"/>
    <ds:schemaRef ds:uri="http://purl.org/dc/dcmitype/"/>
    <ds:schemaRef ds:uri="http://schemas.openxmlformats.org/package/2006/metadata/core-properties"/>
    <ds:schemaRef ds:uri="efe164a0-f0b7-4eea-8df1-2ea8f3834e76"/>
    <ds:schemaRef ds:uri="923bde35-a2ff-4c15-8f8b-a555564e4c68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0</Words>
  <Application>Microsoft Macintosh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ristopher Wilson</cp:lastModifiedBy>
  <cp:revision>7</cp:revision>
  <dcterms:modified xsi:type="dcterms:W3CDTF">2018-02-05T13:21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dlc_DocIdItemGuid">
    <vt:lpwstr>eabef54a-3085-48ac-bd89-08ccd13f155b</vt:lpwstr>
  </property>
  <property fmtid="{D5CDD505-2E9C-101B-9397-08002B2CF9AE}" pid="3" name="ContentTypeId">
    <vt:lpwstr>0x0101007AEF66F112D50C4592BB43B6C12BA42A</vt:lpwstr>
  </property>
</Properties>
</file>